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75" r:id="rId6"/>
    <p:sldId id="276" r:id="rId7"/>
    <p:sldId id="277" r:id="rId8"/>
    <p:sldId id="278" r:id="rId9"/>
    <p:sldId id="279" r:id="rId10"/>
    <p:sldId id="280" r:id="rId11"/>
    <p:sldId id="281" r:id="rId12"/>
    <p:sldId id="282" r:id="rId13"/>
    <p:sldId id="283" r:id="rId14"/>
    <p:sldId id="257" r:id="rId15"/>
    <p:sldId id="258" r:id="rId16"/>
    <p:sldId id="259" r:id="rId17"/>
    <p:sldId id="260" r:id="rId18"/>
    <p:sldId id="261" r:id="rId19"/>
    <p:sldId id="262" r:id="rId20"/>
    <p:sldId id="263" r:id="rId21"/>
    <p:sldId id="264" r:id="rId22"/>
    <p:sldId id="265" r:id="rId23"/>
    <p:sldId id="284" r:id="rId2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1288D47-54A1-4B3B-AA6D-8CD58D285589}" v="13" dt="2021-02-08T23:43:44.7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514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viewProps" Target="viewProps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02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231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33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770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074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133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173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369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628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836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255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D2328-93AC-43BB-9BF4-CF0B9B95D9F2}" type="datetimeFigureOut">
              <a:rPr lang="en-US" smtClean="0"/>
              <a:t>2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46D39C-97C9-4CFE-849E-133AA6499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171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9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Western Blot-Original Blots</a:t>
            </a:r>
          </a:p>
        </p:txBody>
      </p:sp>
    </p:spTree>
    <p:extLst>
      <p:ext uri="{BB962C8B-B14F-4D97-AF65-F5344CB8AC3E}">
        <p14:creationId xmlns:p14="http://schemas.microsoft.com/office/powerpoint/2010/main" val="41041088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62708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2D Caspase 9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763600" y="1825625"/>
            <a:ext cx="6664799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78652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62708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Total Caspase 3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2049113"/>
            <a:ext cx="10515600" cy="39043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18302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590843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Cleaved Caspase 3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54" t="119" r="-311" b="-1825"/>
          <a:stretch/>
        </p:blipFill>
        <p:spPr>
          <a:xfrm>
            <a:off x="838200" y="1995947"/>
            <a:ext cx="10515600" cy="4010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12059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48640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1B1 Caspase 3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0" y="1841738"/>
            <a:ext cx="10515600" cy="4319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21336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48640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Total and Cleaved Caspase 8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 flipH="1">
            <a:off x="4228092" y="1825625"/>
            <a:ext cx="3735816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87413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604911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1A Caspase 8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 flipH="1">
            <a:off x="1211438" y="1825625"/>
            <a:ext cx="9769124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486621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604911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1B Cleaved and Caspase 9</a:t>
            </a:r>
          </a:p>
        </p:txBody>
      </p:sp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02539569-35F2-4B4B-A62F-1633DE0E3F9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 flipH="1">
            <a:off x="3147939" y="1825625"/>
            <a:ext cx="5896121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37848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590843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1B Caspase 9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 flipH="1">
            <a:off x="1153057" y="1825625"/>
            <a:ext cx="9885885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21132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520505"/>
          </a:xfrm>
        </p:spPr>
        <p:txBody>
          <a:bodyPr>
            <a:normAutofit/>
          </a:bodyPr>
          <a:lstStyle/>
          <a:p>
            <a:r>
              <a:rPr lang="en-US" sz="2000" b="1" dirty="0">
                <a:latin typeface="Arial Black" panose="020B0A04020102020204" pitchFamily="34" charset="0"/>
                <a:cs typeface="Arial" panose="020B0604020202020204" pitchFamily="34" charset="0"/>
              </a:rPr>
              <a:t>Total and Cleaved Caspase 7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237638" y="1825625"/>
            <a:ext cx="571672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089116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590843"/>
          </a:xfrm>
        </p:spPr>
        <p:txBody>
          <a:bodyPr>
            <a:normAutofit/>
          </a:bodyPr>
          <a:lstStyle/>
          <a:p>
            <a:r>
              <a:rPr lang="en-US" sz="2000" b="1" dirty="0">
                <a:latin typeface="Arial Black" panose="020B0A04020102020204" pitchFamily="34" charset="0"/>
                <a:cs typeface="Arial" panose="020B0604020202020204" pitchFamily="34" charset="0"/>
              </a:rPr>
              <a:t>1A1 Caspase 7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19484" y="1825625"/>
            <a:ext cx="3353031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67305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703385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Total Caspase 3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883940" y="1825625"/>
            <a:ext cx="4424120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166530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B8EB5A3-4ECB-4097-9968-F9F129F918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3144876"/>
              </p:ext>
            </p:extLst>
          </p:nvPr>
        </p:nvGraphicFramePr>
        <p:xfrm>
          <a:off x="153988" y="773113"/>
          <a:ext cx="11817618" cy="57193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Worksheet" r:id="rId3" imgW="11592043" imgH="5610372" progId="Excel.Sheet.12">
                  <p:embed/>
                </p:oleObj>
              </mc:Choice>
              <mc:Fallback>
                <p:oleObj name="Worksheet" r:id="rId3" imgW="11592043" imgH="5610372" progId="Excel.Sheet.12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B8EB5A3-4ECB-4097-9968-F9F129F918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3988" y="773113"/>
                        <a:ext cx="11817618" cy="57193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-2" y="0"/>
            <a:ext cx="12192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Densitometry Measurements and Calculations</a:t>
            </a:r>
          </a:p>
        </p:txBody>
      </p:sp>
    </p:spTree>
    <p:extLst>
      <p:ext uri="{BB962C8B-B14F-4D97-AF65-F5344CB8AC3E}">
        <p14:creationId xmlns:p14="http://schemas.microsoft.com/office/powerpoint/2010/main" val="3188284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675249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Cleaved Caspase 3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797827" y="1825625"/>
            <a:ext cx="4596346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00023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62708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2A Caspase 3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794922" y="1825625"/>
            <a:ext cx="6602156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20616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48640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Total and Cleaved Caspase 7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572410" y="1825625"/>
            <a:ext cx="5047180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1639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590843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2B Caspase 7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523364" y="1825625"/>
            <a:ext cx="7145272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4706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62708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Total and Cleaved Caspase 8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272789" y="1825625"/>
            <a:ext cx="3646421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07182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562708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2C Caspase 8 Actin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920411" y="1825625"/>
            <a:ext cx="6351177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31341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520505"/>
          </a:xfrm>
        </p:spPr>
        <p:txBody>
          <a:bodyPr>
            <a:normAutofit/>
          </a:bodyPr>
          <a:lstStyle/>
          <a:p>
            <a:r>
              <a:rPr lang="en-US" sz="2000" dirty="0">
                <a:latin typeface="Arial Black" panose="020B0A04020102020204" pitchFamily="34" charset="0"/>
              </a:rPr>
              <a:t>Total and Cleaved Caspase 9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966179" y="1825625"/>
            <a:ext cx="4259642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3980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084256BA9C78E438A19278050672939" ma:contentTypeVersion="12" ma:contentTypeDescription="Create a new document." ma:contentTypeScope="" ma:versionID="b25e4dbf7ef83fc6de2dcdfa9be3897c">
  <xsd:schema xmlns:xsd="http://www.w3.org/2001/XMLSchema" xmlns:xs="http://www.w3.org/2001/XMLSchema" xmlns:p="http://schemas.microsoft.com/office/2006/metadata/properties" xmlns:ns3="4aef11d6-2097-4293-bf2d-d8e0a65a3420" xmlns:ns4="00792fb1-6528-48eb-b4ea-66eb15da5549" targetNamespace="http://schemas.microsoft.com/office/2006/metadata/properties" ma:root="true" ma:fieldsID="1cf019e747cc01b76768d004e2c966cc" ns3:_="" ns4:_="">
    <xsd:import namespace="4aef11d6-2097-4293-bf2d-d8e0a65a3420"/>
    <xsd:import namespace="00792fb1-6528-48eb-b4ea-66eb15da554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aef11d6-2097-4293-bf2d-d8e0a65a342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0792fb1-6528-48eb-b4ea-66eb15da5549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0EC58D5-0E1E-4232-8112-718DA39393B1}">
  <ds:schemaRefs>
    <ds:schemaRef ds:uri="http://purl.org/dc/elements/1.1/"/>
    <ds:schemaRef ds:uri="00792fb1-6528-48eb-b4ea-66eb15da5549"/>
    <ds:schemaRef ds:uri="http://schemas.microsoft.com/office/2006/metadata/properties"/>
    <ds:schemaRef ds:uri="http://purl.org/dc/terms/"/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4aef11d6-2097-4293-bf2d-d8e0a65a3420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E4B21FC-EBD3-4D9C-87E2-CD4CA853384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84E1BA6-E69F-45C4-B259-CA5A045BDA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aef11d6-2097-4293-bf2d-d8e0a65a3420"/>
    <ds:schemaRef ds:uri="00792fb1-6528-48eb-b4ea-66eb15da554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81</Words>
  <Application>Microsoft Office PowerPoint</Application>
  <PresentationFormat>Widescreen</PresentationFormat>
  <Paragraphs>20</Paragraphs>
  <Slides>2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6" baseType="lpstr">
      <vt:lpstr>Arial</vt:lpstr>
      <vt:lpstr>Arial Black</vt:lpstr>
      <vt:lpstr>Calibri</vt:lpstr>
      <vt:lpstr>Calibri Light</vt:lpstr>
      <vt:lpstr>Office Theme</vt:lpstr>
      <vt:lpstr>Worksheet</vt:lpstr>
      <vt:lpstr>Western Blot-Original Blots</vt:lpstr>
      <vt:lpstr>Total Caspase 3</vt:lpstr>
      <vt:lpstr>Cleaved Caspase 3</vt:lpstr>
      <vt:lpstr>2A Caspase 3 Actin</vt:lpstr>
      <vt:lpstr>Total and Cleaved Caspase 7</vt:lpstr>
      <vt:lpstr>2B Caspase 7 Actin</vt:lpstr>
      <vt:lpstr>Total and Cleaved Caspase 8</vt:lpstr>
      <vt:lpstr>2C Caspase 8 Actin</vt:lpstr>
      <vt:lpstr>Total and Cleaved Caspase 9</vt:lpstr>
      <vt:lpstr>2D Caspase 9 Actin</vt:lpstr>
      <vt:lpstr>Total Caspase 3</vt:lpstr>
      <vt:lpstr>Cleaved Caspase 3</vt:lpstr>
      <vt:lpstr>1B1 Caspase 3 Actin</vt:lpstr>
      <vt:lpstr>Total and Cleaved Caspase 8</vt:lpstr>
      <vt:lpstr>1A Caspase 8 Actin</vt:lpstr>
      <vt:lpstr>1B Cleaved and Caspase 9</vt:lpstr>
      <vt:lpstr>1B Caspase 9 Actin</vt:lpstr>
      <vt:lpstr>Total and Cleaved Caspase 7</vt:lpstr>
      <vt:lpstr>1A1 Caspase 7 Actin</vt:lpstr>
      <vt:lpstr>PowerPoint Presentation</vt:lpstr>
    </vt:vector>
  </TitlesOfParts>
  <Company>Thomas Jeffers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uradha Shastri</dc:creator>
  <cp:lastModifiedBy>MDPI</cp:lastModifiedBy>
  <cp:revision>9</cp:revision>
  <dcterms:created xsi:type="dcterms:W3CDTF">2021-02-04T21:01:19Z</dcterms:created>
  <dcterms:modified xsi:type="dcterms:W3CDTF">2021-02-18T07:03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084256BA9C78E438A19278050672939</vt:lpwstr>
  </property>
</Properties>
</file>